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8" name="Google Shape;178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21"/>
          <p:cNvSpPr txBox="1"/>
          <p:nvPr/>
        </p:nvSpPr>
        <p:spPr>
          <a:xfrm>
            <a:off x="453390" y="5161570"/>
            <a:ext cx="5833110" cy="13849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2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2 (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TY36101.1; Amy2). Peptides are shown in alternating colors (black/red) and those with the same amino acid sequences are stacked to show the number of times a peptide sequence was recovered from peptide sequencing analysis. In total coverage 27 peptides for TaAmy2 were recovered and represent 55% amino acid sequence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1" name="Google Shape;181;p2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57200" y="460901"/>
            <a:ext cx="5943600" cy="432511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73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5:43Z</dcterms:modified>
</cp:coreProperties>
</file>